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2" d="100"/>
          <a:sy n="72" d="100"/>
        </p:scale>
        <p:origin x="76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4750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479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4046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0102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4353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5670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3536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2110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4381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777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90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924CD-92B4-4D6D-92E3-B3813C63B0CD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5814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7097" y="609600"/>
            <a:ext cx="7845286" cy="5300869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1311965" y="6016486"/>
            <a:ext cx="9727095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.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stribution of the ΔK parameter resulting from STRUCTURE analysis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07883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DZ-Forum.n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3</cp:revision>
  <dcterms:created xsi:type="dcterms:W3CDTF">2019-04-29T13:19:35Z</dcterms:created>
  <dcterms:modified xsi:type="dcterms:W3CDTF">2019-04-29T13:40:08Z</dcterms:modified>
</cp:coreProperties>
</file>